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tags/tag6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662" y="84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899153" y="914462"/>
            <a:ext cx="7349831" cy="2570573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899153" y="3560640"/>
            <a:ext cx="7349831" cy="1472499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9435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456327" y="774052"/>
            <a:ext cx="8230083" cy="548317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899153" y="2484168"/>
            <a:ext cx="7349831" cy="1018869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899153" y="3560640"/>
            <a:ext cx="7349831" cy="471632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456327" y="1490501"/>
            <a:ext cx="8227383" cy="475952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493188" y="3848660"/>
            <a:ext cx="5826942" cy="76685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493188" y="4615511"/>
            <a:ext cx="5826942" cy="867659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4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456327" y="1501301"/>
            <a:ext cx="3882828" cy="474872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808982" y="1501301"/>
            <a:ext cx="3882828" cy="474872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456327" y="1429296"/>
            <a:ext cx="4007035" cy="38162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56327" y="1854125"/>
            <a:ext cx="4007035" cy="439589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4677087" y="1421825"/>
            <a:ext cx="4007035" cy="38162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4677087" y="1854125"/>
            <a:ext cx="4007035" cy="439589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456274" y="1555220"/>
            <a:ext cx="3925006" cy="460850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4763079" y="1555305"/>
            <a:ext cx="3920630" cy="460831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2/9/20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7676550" y="914462"/>
            <a:ext cx="783046" cy="5029539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685840" y="914462"/>
            <a:ext cx="6877303" cy="5029539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456327" y="608441"/>
            <a:ext cx="8227383" cy="705648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456327" y="1490501"/>
            <a:ext cx="8227383" cy="4759521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459027" y="6314826"/>
            <a:ext cx="2025119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3087181" y="6314826"/>
            <a:ext cx="2970174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6658591" y="6314826"/>
            <a:ext cx="2025119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435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9435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41B9A8F-14B6-4793-887D-C720FC562769}"/>
              </a:ext>
            </a:extLst>
          </p:cNvPr>
          <p:cNvSpPr txBox="1"/>
          <p:nvPr/>
        </p:nvSpPr>
        <p:spPr>
          <a:xfrm>
            <a:off x="148974" y="216698"/>
            <a:ext cx="733061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/>
              <a:t>Additional file 1 </a:t>
            </a:r>
            <a:r>
              <a:rPr lang="en-US" altLang="zh-CN" sz="1400" dirty="0"/>
              <a:t>Preparation for </a:t>
            </a:r>
            <a:r>
              <a:rPr lang="en-US" altLang="zh-CN" sz="1400" dirty="0" err="1"/>
              <a:t>iTRAQ</a:t>
            </a:r>
            <a:r>
              <a:rPr lang="en-US" altLang="zh-CN" sz="1400" dirty="0"/>
              <a:t> quantitative proteomics study.</a:t>
            </a:r>
            <a:endParaRPr lang="zh-CN" altLang="en-US" sz="14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9F6AE491-DFEE-4825-8C42-AA4BFCD74294}"/>
              </a:ext>
            </a:extLst>
          </p:cNvPr>
          <p:cNvSpPr txBox="1"/>
          <p:nvPr/>
        </p:nvSpPr>
        <p:spPr>
          <a:xfrm>
            <a:off x="742222" y="5868808"/>
            <a:ext cx="785724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/>
              <a:t>A, SDS-PAGE separation of whole cellular lysates of </a:t>
            </a:r>
            <a:r>
              <a:rPr lang="en-US" altLang="zh-CN" sz="1200" i="1" dirty="0"/>
              <a:t>D. </a:t>
            </a:r>
            <a:r>
              <a:rPr lang="en-US" altLang="zh-CN" sz="1200" i="1" dirty="0" err="1"/>
              <a:t>radiodurans</a:t>
            </a:r>
            <a:r>
              <a:rPr lang="en-US" altLang="zh-CN" sz="1200" i="1" dirty="0"/>
              <a:t> </a:t>
            </a:r>
            <a:r>
              <a:rPr lang="en-US" altLang="zh-CN" sz="1200" dirty="0"/>
              <a:t>treated with different dose of heavy ion irradiation. </a:t>
            </a:r>
          </a:p>
          <a:p>
            <a:r>
              <a:rPr lang="en-US" altLang="zh-CN" sz="1200" dirty="0"/>
              <a:t>B, Sample preparation for </a:t>
            </a:r>
            <a:r>
              <a:rPr lang="en-US" altLang="zh-CN" sz="1200" dirty="0" err="1"/>
              <a:t>iTRAQ</a:t>
            </a:r>
            <a:r>
              <a:rPr lang="en-US" altLang="zh-CN" sz="1200" dirty="0"/>
              <a:t> labeling. </a:t>
            </a:r>
          </a:p>
          <a:p>
            <a:r>
              <a:rPr lang="en-US" altLang="zh-CN" sz="1200" dirty="0"/>
              <a:t>C, Representative extracted ion current (XIC) analysis for LC-MS/MS on the </a:t>
            </a:r>
            <a:r>
              <a:rPr lang="en-US" altLang="zh-CN" sz="1200" dirty="0" err="1"/>
              <a:t>iTRAQ</a:t>
            </a:r>
            <a:r>
              <a:rPr lang="en-US" altLang="zh-CN" sz="1200" dirty="0"/>
              <a:t> labeled samples. </a:t>
            </a:r>
          </a:p>
          <a:p>
            <a:r>
              <a:rPr lang="en-US" altLang="zh-CN" sz="1200" dirty="0"/>
              <a:t>D, Liquid-phase separation diagram of labeled peptide mixtures.</a:t>
            </a:r>
            <a:endParaRPr lang="zh-CN" altLang="en-US" sz="1200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38419746-91F9-427C-B87E-7EF3EB0B79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2372" y="661176"/>
            <a:ext cx="6719712" cy="5110132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69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an</dc:creator>
  <cp:lastModifiedBy>2021027@njau.edu.cn</cp:lastModifiedBy>
  <cp:revision>186</cp:revision>
  <dcterms:created xsi:type="dcterms:W3CDTF">2019-06-19T02:08:00Z</dcterms:created>
  <dcterms:modified xsi:type="dcterms:W3CDTF">2022-09-20T03:27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365</vt:lpwstr>
  </property>
  <property fmtid="{D5CDD505-2E9C-101B-9397-08002B2CF9AE}" pid="3" name="ICV">
    <vt:lpwstr>15C065FB1E98446EAA189C1A1E1155ED</vt:lpwstr>
  </property>
</Properties>
</file>